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  <p:sldId id="259" r:id="rId4"/>
    <p:sldId id="262" r:id="rId5"/>
  </p:sldIdLst>
  <p:sldSz cx="6858000" cy="97266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787"/>
    <p:restoredTop sz="96405"/>
  </p:normalViewPr>
  <p:slideViewPr>
    <p:cSldViewPr snapToGrid="0" showGuides="1">
      <p:cViewPr varScale="1">
        <p:scale>
          <a:sx n="78" d="100"/>
          <a:sy n="78" d="100"/>
        </p:scale>
        <p:origin x="3000" y="114"/>
      </p:cViewPr>
      <p:guideLst>
        <p:guide orient="horz" pos="304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91833"/>
            <a:ext cx="5829300" cy="338630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108724"/>
            <a:ext cx="5143500" cy="234834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432275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5518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17852"/>
            <a:ext cx="1478756" cy="824285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17852"/>
            <a:ext cx="4350544" cy="824285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978159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2365429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24902"/>
            <a:ext cx="5915025" cy="404600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509178"/>
            <a:ext cx="5915025" cy="212769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797555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89260"/>
            <a:ext cx="2914650" cy="61714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89260"/>
            <a:ext cx="2914650" cy="61714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410986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7854"/>
            <a:ext cx="5915025" cy="188002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84372"/>
            <a:ext cx="2901255" cy="116854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552915"/>
            <a:ext cx="2901255" cy="52258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84372"/>
            <a:ext cx="2915543" cy="116854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552915"/>
            <a:ext cx="2915543" cy="52258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985886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812013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820840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441"/>
            <a:ext cx="2211884" cy="226954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00454"/>
            <a:ext cx="3471863" cy="69122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7984"/>
            <a:ext cx="2211884" cy="54059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1335322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8441"/>
            <a:ext cx="2211884" cy="226954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00454"/>
            <a:ext cx="3471863" cy="69122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17984"/>
            <a:ext cx="2211884" cy="54059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8798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17854"/>
            <a:ext cx="5915025" cy="1880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89260"/>
            <a:ext cx="5915025" cy="61714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015131"/>
            <a:ext cx="1543050" cy="5178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3DC147-1682-A64D-9A90-D83675483FB2}" type="datetimeFigureOut">
              <a:rPr lang="en-KR" smtClean="0"/>
              <a:t>03/26/2025</a:t>
            </a:fld>
            <a:endParaRPr lang="en-K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015131"/>
            <a:ext cx="2314575" cy="5178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K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015131"/>
            <a:ext cx="1543050" cy="51785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1D8AA-8E13-5C46-A9EA-9D9FB938AE3E}" type="slidenum">
              <a:rPr lang="en-KR" smtClean="0"/>
              <a:t>‹#›</a:t>
            </a:fld>
            <a:endParaRPr lang="en-KR"/>
          </a:p>
        </p:txBody>
      </p:sp>
    </p:spTree>
    <p:extLst>
      <p:ext uri="{BB962C8B-B14F-4D97-AF65-F5344CB8AC3E}">
        <p14:creationId xmlns:p14="http://schemas.microsoft.com/office/powerpoint/2010/main" val="3840137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E51AA0F-98B4-65F4-3565-81807CBEE888}"/>
              </a:ext>
            </a:extLst>
          </p:cNvPr>
          <p:cNvSpPr txBox="1"/>
          <p:nvPr/>
        </p:nvSpPr>
        <p:spPr>
          <a:xfrm>
            <a:off x="149902" y="119922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Figure S1</a:t>
            </a:r>
          </a:p>
        </p:txBody>
      </p:sp>
      <p:grpSp>
        <p:nvGrpSpPr>
          <p:cNvPr id="2" name="그룹 13">
            <a:extLst>
              <a:ext uri="{FF2B5EF4-FFF2-40B4-BE49-F238E27FC236}">
                <a16:creationId xmlns:a16="http://schemas.microsoft.com/office/drawing/2014/main" id="{DDBC5803-44B9-88FA-E734-F807F421692D}"/>
              </a:ext>
            </a:extLst>
          </p:cNvPr>
          <p:cNvGrpSpPr>
            <a:grpSpLocks noChangeAspect="1"/>
          </p:cNvGrpSpPr>
          <p:nvPr/>
        </p:nvGrpSpPr>
        <p:grpSpPr>
          <a:xfrm>
            <a:off x="221105" y="836934"/>
            <a:ext cx="2880000" cy="2757116"/>
            <a:chOff x="680397" y="1588340"/>
            <a:chExt cx="3607824" cy="3453885"/>
          </a:xfrm>
        </p:grpSpPr>
        <p:pic>
          <p:nvPicPr>
            <p:cNvPr id="3" name="그림 7">
              <a:extLst>
                <a:ext uri="{FF2B5EF4-FFF2-40B4-BE49-F238E27FC236}">
                  <a16:creationId xmlns:a16="http://schemas.microsoft.com/office/drawing/2014/main" id="{651F808D-E3C9-A316-2655-95906738230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80397" y="1588340"/>
              <a:ext cx="3113810" cy="3453885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BE62F56-AE8C-ABC4-1E04-0F0FD657072E}"/>
                </a:ext>
              </a:extLst>
            </p:cNvPr>
            <p:cNvSpPr txBox="1"/>
            <p:nvPr/>
          </p:nvSpPr>
          <p:spPr>
            <a:xfrm>
              <a:off x="1920270" y="1588340"/>
              <a:ext cx="2367951" cy="4241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ko-Kore-KR" sz="800" b="1" dirty="0"/>
                <a:t>median PFS : 5.6 months </a:t>
              </a:r>
            </a:p>
            <a:p>
              <a:pPr algn="ctr"/>
              <a:r>
                <a:rPr kumimoji="1" lang="en-US" altLang="ko-Kore-KR" sz="800" b="1" dirty="0"/>
                <a:t>(95% CI 3.54~9.28)</a:t>
              </a:r>
              <a:endParaRPr kumimoji="1" lang="ko-Kore-KR" altLang="en-US" sz="800" b="1" dirty="0"/>
            </a:p>
          </p:txBody>
        </p:sp>
      </p:grpSp>
      <p:grpSp>
        <p:nvGrpSpPr>
          <p:cNvPr id="6" name="그룹 12">
            <a:extLst>
              <a:ext uri="{FF2B5EF4-FFF2-40B4-BE49-F238E27FC236}">
                <a16:creationId xmlns:a16="http://schemas.microsoft.com/office/drawing/2014/main" id="{36D8D599-DE62-590E-77DF-0FE76FC3D191}"/>
              </a:ext>
            </a:extLst>
          </p:cNvPr>
          <p:cNvGrpSpPr>
            <a:grpSpLocks noChangeAspect="1"/>
          </p:cNvGrpSpPr>
          <p:nvPr/>
        </p:nvGrpSpPr>
        <p:grpSpPr>
          <a:xfrm>
            <a:off x="3696498" y="836934"/>
            <a:ext cx="2880000" cy="2677218"/>
            <a:chOff x="5034079" y="1588340"/>
            <a:chExt cx="3715495" cy="3453885"/>
          </a:xfrm>
        </p:grpSpPr>
        <p:pic>
          <p:nvPicPr>
            <p:cNvPr id="7" name="그림 10">
              <a:extLst>
                <a:ext uri="{FF2B5EF4-FFF2-40B4-BE49-F238E27FC236}">
                  <a16:creationId xmlns:a16="http://schemas.microsoft.com/office/drawing/2014/main" id="{B4B78031-B60C-BF4C-0A45-BD5D1AA5122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34079" y="1588340"/>
              <a:ext cx="3113810" cy="345388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148FD6C-2F40-15F3-0BC3-53E01CDEA9F1}"/>
                </a:ext>
              </a:extLst>
            </p:cNvPr>
            <p:cNvSpPr txBox="1"/>
            <p:nvPr/>
          </p:nvSpPr>
          <p:spPr>
            <a:xfrm>
              <a:off x="6381622" y="1588340"/>
              <a:ext cx="2367952" cy="436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ko-Kore-KR" sz="800" b="1" dirty="0"/>
                <a:t>median DOR : 5.8 months </a:t>
              </a:r>
            </a:p>
            <a:p>
              <a:pPr algn="ctr"/>
              <a:r>
                <a:rPr kumimoji="1" lang="en-US" altLang="ko-Kore-KR" sz="800" b="1" dirty="0"/>
                <a:t>(95% CI 3.31~NE)</a:t>
              </a:r>
              <a:endParaRPr kumimoji="1" lang="ko-Kore-KR" altLang="en-US" sz="800" b="1" dirty="0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23ED711C-15F7-C6C0-DDCA-0F93E439D539}"/>
              </a:ext>
            </a:extLst>
          </p:cNvPr>
          <p:cNvSpPr txBox="1"/>
          <p:nvPr/>
        </p:nvSpPr>
        <p:spPr>
          <a:xfrm>
            <a:off x="149902" y="529157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48346C-5353-8B15-FE2E-8767C42F24ED}"/>
              </a:ext>
            </a:extLst>
          </p:cNvPr>
          <p:cNvSpPr txBox="1"/>
          <p:nvPr/>
        </p:nvSpPr>
        <p:spPr>
          <a:xfrm>
            <a:off x="3429000" y="529157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70060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E51AA0F-98B4-65F4-3565-81807CBEE888}"/>
              </a:ext>
            </a:extLst>
          </p:cNvPr>
          <p:cNvSpPr txBox="1"/>
          <p:nvPr/>
        </p:nvSpPr>
        <p:spPr>
          <a:xfrm>
            <a:off x="149902" y="119922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Figure S2</a:t>
            </a:r>
          </a:p>
        </p:txBody>
      </p:sp>
      <p:pic>
        <p:nvPicPr>
          <p:cNvPr id="14" name="그림 4">
            <a:extLst>
              <a:ext uri="{FF2B5EF4-FFF2-40B4-BE49-F238E27FC236}">
                <a16:creationId xmlns:a16="http://schemas.microsoft.com/office/drawing/2014/main" id="{1E452747-5E37-5721-F1E2-D6223E7043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478" y="659756"/>
            <a:ext cx="6487043" cy="40142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299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E51AA0F-98B4-65F4-3565-81807CBEE888}"/>
              </a:ext>
            </a:extLst>
          </p:cNvPr>
          <p:cNvSpPr txBox="1"/>
          <p:nvPr/>
        </p:nvSpPr>
        <p:spPr>
          <a:xfrm>
            <a:off x="149902" y="119922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Figure S3</a:t>
            </a:r>
          </a:p>
        </p:txBody>
      </p:sp>
      <p:grpSp>
        <p:nvGrpSpPr>
          <p:cNvPr id="2" name="그룹 24">
            <a:extLst>
              <a:ext uri="{FF2B5EF4-FFF2-40B4-BE49-F238E27FC236}">
                <a16:creationId xmlns:a16="http://schemas.microsoft.com/office/drawing/2014/main" id="{CF1EF843-F75D-9A50-9FF4-2737A8EB382D}"/>
              </a:ext>
            </a:extLst>
          </p:cNvPr>
          <p:cNvGrpSpPr/>
          <p:nvPr/>
        </p:nvGrpSpPr>
        <p:grpSpPr>
          <a:xfrm>
            <a:off x="194337" y="592282"/>
            <a:ext cx="6469326" cy="4405702"/>
            <a:chOff x="337875" y="2384564"/>
            <a:chExt cx="6469326" cy="4405702"/>
          </a:xfrm>
        </p:grpSpPr>
        <p:grpSp>
          <p:nvGrpSpPr>
            <p:cNvPr id="3" name="그룹 6">
              <a:extLst>
                <a:ext uri="{FF2B5EF4-FFF2-40B4-BE49-F238E27FC236}">
                  <a16:creationId xmlns:a16="http://schemas.microsoft.com/office/drawing/2014/main" id="{AC2C144A-D592-4506-D65F-06CD3A39E2FB}"/>
                </a:ext>
              </a:extLst>
            </p:cNvPr>
            <p:cNvGrpSpPr/>
            <p:nvPr/>
          </p:nvGrpSpPr>
          <p:grpSpPr>
            <a:xfrm>
              <a:off x="337875" y="2384564"/>
              <a:ext cx="6469326" cy="4405702"/>
              <a:chOff x="337875" y="2384564"/>
              <a:chExt cx="6469326" cy="4405702"/>
            </a:xfrm>
          </p:grpSpPr>
          <p:pic>
            <p:nvPicPr>
              <p:cNvPr id="19" name="그림 4">
                <a:extLst>
                  <a:ext uri="{FF2B5EF4-FFF2-40B4-BE49-F238E27FC236}">
                    <a16:creationId xmlns:a16="http://schemas.microsoft.com/office/drawing/2014/main" id="{DDACCEE7-150C-F909-2831-DA75719D35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1935" r="14830"/>
              <a:stretch/>
            </p:blipFill>
            <p:spPr>
              <a:xfrm>
                <a:off x="337875" y="2384564"/>
                <a:ext cx="6469326" cy="4405702"/>
              </a:xfrm>
              <a:prstGeom prst="rect">
                <a:avLst/>
              </a:prstGeom>
            </p:spPr>
          </p:pic>
          <p:pic>
            <p:nvPicPr>
              <p:cNvPr id="20" name="그림 5">
                <a:extLst>
                  <a:ext uri="{FF2B5EF4-FFF2-40B4-BE49-F238E27FC236}">
                    <a16:creationId xmlns:a16="http://schemas.microsoft.com/office/drawing/2014/main" id="{CFB28E19-39D4-C125-6F52-B7A0A3C3AA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5094" t="29472" r="855" b="34015"/>
              <a:stretch/>
            </p:blipFill>
            <p:spPr>
              <a:xfrm>
                <a:off x="5638801" y="4885444"/>
                <a:ext cx="1092201" cy="1608667"/>
              </a:xfrm>
              <a:prstGeom prst="rect">
                <a:avLst/>
              </a:prstGeom>
            </p:spPr>
          </p:pic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0ABA2CD-9F4E-6A0F-D8EC-5895A12B0638}"/>
                </a:ext>
              </a:extLst>
            </p:cNvPr>
            <p:cNvSpPr txBox="1"/>
            <p:nvPr/>
          </p:nvSpPr>
          <p:spPr>
            <a:xfrm>
              <a:off x="838005" y="2461587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6C60E9F-3B9C-AAF6-6A6B-6FBD70D576B5}"/>
                </a:ext>
              </a:extLst>
            </p:cNvPr>
            <p:cNvSpPr txBox="1"/>
            <p:nvPr/>
          </p:nvSpPr>
          <p:spPr>
            <a:xfrm>
              <a:off x="837711" y="2837571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11D4A10-1D57-AC34-A1AD-1F22B5A7EAB6}"/>
                </a:ext>
              </a:extLst>
            </p:cNvPr>
            <p:cNvSpPr txBox="1"/>
            <p:nvPr/>
          </p:nvSpPr>
          <p:spPr>
            <a:xfrm>
              <a:off x="837907" y="3420533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56D8C54-ECAA-DDBD-472F-B98AC6B5AE74}"/>
                </a:ext>
              </a:extLst>
            </p:cNvPr>
            <p:cNvSpPr txBox="1"/>
            <p:nvPr/>
          </p:nvSpPr>
          <p:spPr>
            <a:xfrm>
              <a:off x="837906" y="3034030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39BC4E7-5812-A5A3-643A-BEFC2141733D}"/>
                </a:ext>
              </a:extLst>
            </p:cNvPr>
            <p:cNvSpPr txBox="1"/>
            <p:nvPr/>
          </p:nvSpPr>
          <p:spPr>
            <a:xfrm>
              <a:off x="837906" y="4180970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9267BA2-B287-C3FF-1AF7-B58B066AB272}"/>
                </a:ext>
              </a:extLst>
            </p:cNvPr>
            <p:cNvSpPr txBox="1"/>
            <p:nvPr/>
          </p:nvSpPr>
          <p:spPr>
            <a:xfrm>
              <a:off x="837905" y="4396413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E5348C1-1204-B927-9DB6-4AE8EAAC21B0}"/>
                </a:ext>
              </a:extLst>
            </p:cNvPr>
            <p:cNvSpPr txBox="1"/>
            <p:nvPr/>
          </p:nvSpPr>
          <p:spPr>
            <a:xfrm>
              <a:off x="837711" y="5142523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06F19B-2897-B4F5-C86F-5BBE87A8BEE9}"/>
                </a:ext>
              </a:extLst>
            </p:cNvPr>
            <p:cNvSpPr txBox="1"/>
            <p:nvPr/>
          </p:nvSpPr>
          <p:spPr>
            <a:xfrm>
              <a:off x="837711" y="5715974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64600FA-276F-4043-7326-4FACFE02958A}"/>
                </a:ext>
              </a:extLst>
            </p:cNvPr>
            <p:cNvSpPr txBox="1"/>
            <p:nvPr/>
          </p:nvSpPr>
          <p:spPr>
            <a:xfrm>
              <a:off x="837904" y="5911427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F780ED4-7FBA-ECC4-AAE2-A910B7AF873F}"/>
                </a:ext>
              </a:extLst>
            </p:cNvPr>
            <p:cNvSpPr txBox="1"/>
            <p:nvPr/>
          </p:nvSpPr>
          <p:spPr>
            <a:xfrm>
              <a:off x="837711" y="4760219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00D826A-4CAB-EE94-6383-D7D8B0F378BC}"/>
                </a:ext>
              </a:extLst>
            </p:cNvPr>
            <p:cNvSpPr txBox="1"/>
            <p:nvPr/>
          </p:nvSpPr>
          <p:spPr>
            <a:xfrm>
              <a:off x="837904" y="3978749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F414D8D-95F4-489B-1EB1-FAA37D0E3BC2}"/>
                </a:ext>
              </a:extLst>
            </p:cNvPr>
            <p:cNvSpPr txBox="1"/>
            <p:nvPr/>
          </p:nvSpPr>
          <p:spPr>
            <a:xfrm>
              <a:off x="837710" y="3801413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42B264E-12C6-07DB-1FD1-C6C55409410A}"/>
                </a:ext>
              </a:extLst>
            </p:cNvPr>
            <p:cNvSpPr txBox="1"/>
            <p:nvPr/>
          </p:nvSpPr>
          <p:spPr>
            <a:xfrm>
              <a:off x="837903" y="5528019"/>
              <a:ext cx="1525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ko-Kore-KR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F153C439-1F73-2B27-E75C-DA01358DB4C7}"/>
              </a:ext>
            </a:extLst>
          </p:cNvPr>
          <p:cNvSpPr txBox="1"/>
          <p:nvPr/>
        </p:nvSpPr>
        <p:spPr>
          <a:xfrm>
            <a:off x="3295220" y="5038339"/>
            <a:ext cx="3437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ko-Kore-KR" alt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kumimoji="1" lang="en-US" altLang="ko-Kore-KR" sz="800" b="1" dirty="0">
                <a:latin typeface="Arial" panose="020B0604020202020204" pitchFamily="34" charset="0"/>
                <a:cs typeface="Arial" panose="020B0604020202020204" pitchFamily="34" charset="0"/>
              </a:rPr>
              <a:t> : Patients who have previously received </a:t>
            </a:r>
            <a:r>
              <a:rPr kumimoji="1" lang="en-US" altLang="ko-Kore-K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ivantamab</a:t>
            </a:r>
            <a:r>
              <a:rPr kumimoji="1" lang="en-US" altLang="ko-Kore-KR" sz="800" b="1" dirty="0">
                <a:latin typeface="Arial" panose="020B0604020202020204" pitchFamily="34" charset="0"/>
                <a:cs typeface="Arial" panose="020B0604020202020204" pitchFamily="34" charset="0"/>
              </a:rPr>
              <a:t> treatment</a:t>
            </a:r>
            <a:endParaRPr kumimoji="1" lang="ko-Kore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25909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4C9ED32D-18EC-C9CD-A487-E686D3A90F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240" y="558284"/>
            <a:ext cx="3240000" cy="35938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CAEDB8A-246D-CE1F-F355-C446B8DA6506}"/>
              </a:ext>
            </a:extLst>
          </p:cNvPr>
          <p:cNvSpPr txBox="1"/>
          <p:nvPr/>
        </p:nvSpPr>
        <p:spPr>
          <a:xfrm>
            <a:off x="1869240" y="1132291"/>
            <a:ext cx="2594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800" b="1" dirty="0">
                <a:latin typeface="Arial" panose="020B0604020202020204" pitchFamily="34" charset="0"/>
                <a:cs typeface="Arial" panose="020B0604020202020204" pitchFamily="34" charset="0"/>
              </a:rPr>
              <a:t>Log-Rank </a:t>
            </a:r>
            <a:r>
              <a:rPr kumimoji="1" lang="en-US" altLang="ko-Kore-KR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kumimoji="1"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: 0.86</a:t>
            </a:r>
          </a:p>
          <a:p>
            <a:r>
              <a:rPr kumimoji="1" lang="en-US" altLang="ko-Kore-KR" sz="800" b="1" dirty="0">
                <a:latin typeface="Arial" panose="020B0604020202020204" pitchFamily="34" charset="0"/>
                <a:cs typeface="Arial" panose="020B0604020202020204" pitchFamily="34" charset="0"/>
              </a:rPr>
              <a:t>Median PFS : </a:t>
            </a:r>
            <a:r>
              <a:rPr kumimoji="1" lang="en-US" altLang="ko-Kore-KR" sz="800" b="1" dirty="0">
                <a:solidFill>
                  <a:srgbClr val="FBE1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.8</a:t>
            </a:r>
            <a:r>
              <a:rPr kumimoji="1" lang="en-US" altLang="ko-Kore-KR" sz="800" b="1" dirty="0">
                <a:latin typeface="Arial" panose="020B0604020202020204" pitchFamily="34" charset="0"/>
                <a:cs typeface="Arial" panose="020B0604020202020204" pitchFamily="34" charset="0"/>
              </a:rPr>
              <a:t> vs </a:t>
            </a:r>
            <a:r>
              <a:rPr kumimoji="1" lang="en-US" altLang="ko-Kore-KR" sz="8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3 month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38354B-04FB-3371-EBFB-987AC26A05FB}"/>
              </a:ext>
            </a:extLst>
          </p:cNvPr>
          <p:cNvSpPr txBox="1"/>
          <p:nvPr/>
        </p:nvSpPr>
        <p:spPr>
          <a:xfrm>
            <a:off x="149902" y="119922"/>
            <a:ext cx="989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KR" sz="14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13219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00</TotalTime>
  <Words>67</Words>
  <Application>Microsoft Office PowerPoint</Application>
  <PresentationFormat>사용자 지정</PresentationFormat>
  <Paragraphs>26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hhoon Park</dc:creator>
  <cp:lastModifiedBy>Jinyong Kim</cp:lastModifiedBy>
  <cp:revision>13</cp:revision>
  <dcterms:created xsi:type="dcterms:W3CDTF">2024-08-08T01:08:38Z</dcterms:created>
  <dcterms:modified xsi:type="dcterms:W3CDTF">2025-03-26T00:25:40Z</dcterms:modified>
</cp:coreProperties>
</file>